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40" r:id="rId1"/>
  </p:sldMasterIdLst>
  <p:notesMasterIdLst>
    <p:notesMasterId r:id="rId27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E4A300-2CE8-48AE-A788-2AF5A4ADC38C}" v="67" dt="2021-03-10T18:06:21.248"/>
    <p1510:client id="{2F3C817B-A41B-447B-A416-B20CFE8B5F5B}" v="832" dt="2021-03-10T17:46:27.588"/>
    <p1510:client id="{7F59FAE5-83E3-431F-8631-862E4F9C705C}" v="393" dt="2021-03-10T15:04:48.518"/>
    <p1510:client id="{CD05082E-B08D-4817-8400-261D494A0F57}" v="1" dt="2021-03-10T18:07:18.61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77153" autoAdjust="0"/>
  </p:normalViewPr>
  <p:slideViewPr>
    <p:cSldViewPr>
      <p:cViewPr varScale="1">
        <p:scale>
          <a:sx n="128" d="100"/>
          <a:sy n="128" d="100"/>
        </p:scale>
        <p:origin x="170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microsoft.com/office/2015/10/relationships/revisionInfo" Target="revisionInfo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notesMaster" Target="notesMasters/notesMaster1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CE91A9-0732-4271-88FB-9D1147D3C331}" type="datetimeFigureOut">
              <a:rPr lang="en-US" smtClean="0"/>
              <a:t>4/1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872417-8614-4B09-B5BB-5AA3264E2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8788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ubmed/?term=Than%20M%5BAuthor%5D&amp;cauthor=true&amp;cauthor_uid=24428678" TargetMode="External"/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www.ncbi.nlm.nih.gov/pubmed/24428678" TargetMode="External"/><Relationship Id="rId5" Type="http://schemas.openxmlformats.org/officeDocument/2006/relationships/hyperlink" Target="https://www.ncbi.nlm.nih.gov/pubmed/?term=Sanders%20S%5BAuthor%5D&amp;cauthor=true&amp;cauthor_uid=24428678" TargetMode="External"/><Relationship Id="rId4" Type="http://schemas.openxmlformats.org/officeDocument/2006/relationships/hyperlink" Target="https://www.ncbi.nlm.nih.gov/pubmed/?term=Flaws%20D%5BAuthor%5D&amp;cauthor=true&amp;cauthor_uid=24428678" TargetMode="External"/></Relationships>
</file>

<file path=ppt/notesSlides/_rels/notesSlide13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ncbi.nlm.nih.gov/pubmed/?term=Greenslade%20JH%5BAuthor%5D&amp;cauthor=true&amp;cauthor_uid=24238485" TargetMode="External"/><Relationship Id="rId3" Type="http://schemas.openxmlformats.org/officeDocument/2006/relationships/hyperlink" Target="https://www.ncbi.nlm.nih.gov/pubmed/?term=Scheuermeyer%20FX%5BAuthor%5D&amp;cauthor=true&amp;cauthor_uid=24626115" TargetMode="External"/><Relationship Id="rId7" Type="http://schemas.openxmlformats.org/officeDocument/2006/relationships/hyperlink" Target="https://www.ncbi.nlm.nih.gov/pubmed/?term=Cullen%20L%5BAuthor%5D&amp;cauthor=true&amp;cauthor_uid=24238485" TargetMode="External"/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www.ncbi.nlm.nih.gov/pubmed/24626115" TargetMode="External"/><Relationship Id="rId11" Type="http://schemas.openxmlformats.org/officeDocument/2006/relationships/hyperlink" Target="https://doi.org/10.1016/j.ajem.2013.10.021" TargetMode="External"/><Relationship Id="rId5" Type="http://schemas.openxmlformats.org/officeDocument/2006/relationships/hyperlink" Target="https://www.ncbi.nlm.nih.gov/pubmed/?term=Yu%20E%5BAuthor%5D&amp;cauthor=true&amp;cauthor_uid=24626115" TargetMode="External"/><Relationship Id="rId10" Type="http://schemas.openxmlformats.org/officeDocument/2006/relationships/hyperlink" Target="https://www.ncbi.nlm.nih.gov/pubmed/24238485" TargetMode="External"/><Relationship Id="rId4" Type="http://schemas.openxmlformats.org/officeDocument/2006/relationships/hyperlink" Target="https://www.ncbi.nlm.nih.gov/pubmed/?term=Wong%20H%5BAuthor%5D&amp;cauthor=true&amp;cauthor_uid=24626115" TargetMode="External"/><Relationship Id="rId9" Type="http://schemas.openxmlformats.org/officeDocument/2006/relationships/hyperlink" Target="https://www.ncbi.nlm.nih.gov/pubmed/?term=Than%20M%5BAuthor%5D&amp;cauthor=true&amp;cauthor_uid=24238485" TargetMode="Externa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ncbi.nlm.nih.gov/pubmed/25622287" TargetMode="External"/><Relationship Id="rId3" Type="http://schemas.openxmlformats.org/officeDocument/2006/relationships/hyperlink" Target="https://www.ncbi.nlm.nih.gov/pubmed/?term=Foy%20AJ%5BAuthor%5D&amp;cauthor=true&amp;cauthor_uid=25622287" TargetMode="External"/><Relationship Id="rId7" Type="http://schemas.openxmlformats.org/officeDocument/2006/relationships/hyperlink" Target="https://www.ncbi.nlm.nih.gov/pubmed/?term=Leslie%20DL%5BAuthor%5D&amp;cauthor=true&amp;cauthor_uid=25622287" TargetMode="External"/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www.ncbi.nlm.nih.gov/pubmed/?term=Sciamanna%20C%5BAuthor%5D&amp;cauthor=true&amp;cauthor_uid=25622287" TargetMode="External"/><Relationship Id="rId5" Type="http://schemas.openxmlformats.org/officeDocument/2006/relationships/hyperlink" Target="https://www.ncbi.nlm.nih.gov/pubmed/?term=Davidson%20WR%20Jr%5BAuthor%5D&amp;cauthor=true&amp;cauthor_uid=25622287" TargetMode="External"/><Relationship Id="rId4" Type="http://schemas.openxmlformats.org/officeDocument/2006/relationships/hyperlink" Target="https://www.ncbi.nlm.nih.gov/pubmed/?term=Liu%20G%5BAuthor%5D&amp;cauthor=true&amp;cauthor_uid=25622287" TargetMode="Externa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ubmed/?term=Asher%20E%5BAuthor%5D&amp;cauthor=true&amp;cauthor_uid=25622029" TargetMode="External"/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s://www.ncbi.nlm.nih.gov/pubmed/?term=Shlomo%20N%5BAuthor%5D&amp;cauthor=true&amp;cauthor_uid=25622029" TargetMode="External"/><Relationship Id="rId4" Type="http://schemas.openxmlformats.org/officeDocument/2006/relationships/hyperlink" Target="https://www.ncbi.nlm.nih.gov/pubmed/?term=Reuveni%20H%5BAuthor%5D&amp;cauthor=true&amp;cauthor_uid=25622029" TargetMode="Externa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war EW, Niska RW, Xu J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National Hospital Ambulatory Medical Care Survey: 2005 Emergency Department Summary: Advanced Data From Vital and Health Statistics; No. 386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yattsville, MD: National Center for Health Statistics; 2007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43742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agam KG, Tamhane UU, Kline-Rogers E, et al. Does Simplicity Compromise Accuracy in ACS Risk Prediction? A Retrospective Analysis of the TIMI and GRACE Risk Scores. PLOS ONE 4(11): e7947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llack CV, Sites FD, Shofer FS, Sease KL, Hollander JE. Application of the TIMI Risk Score for Unstable Angina and Non-ST Elevation Acute Coronary Syndrome to an Unselected Emergency Department Chest Pain Population. Academic Emergency Medicine. 2006;13:13–18. doi:10.1197/j.aem.2005.06.031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05182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 chart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2214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Than M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/>
              </a:rPr>
              <a:t>Flaws 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5"/>
              </a:rPr>
              <a:t>Sanders 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et al. Development and validation of the Emergency Department Assessment of Chest pain Score and 2 h accelerated diagnostic protocol;  </a:t>
            </a:r>
            <a:r>
              <a:rPr lang="en-US" sz="120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 tooltip="Emergency medicine Australasia : EMA."/>
              </a:rPr>
              <a:t>Emerg Med </a:t>
            </a:r>
            <a:r>
              <a:rPr lang="en-US" sz="1200" i="1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 tooltip="Emergency medicine Australasia : EMA."/>
              </a:rPr>
              <a:t>Australas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 tooltip="Emergency medicine Australasia : EMA."/>
              </a:rPr>
              <a:t>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14; Feb;26(1):34-44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62921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istenson J, Innes G, McKnight D, et al. A clinical prediction rule for early discharge of patients with chest pain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Ann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erg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006;47(1):1–10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Scheuermeyer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 FX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/>
              </a:rPr>
              <a:t>Wong 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5"/>
              </a:rPr>
              <a:t>Yu 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Development and validation of a prediction rule for early discharge of low-risk emergency department patients with potential ischemic chest pain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r>
              <a:rPr lang="en-US" sz="120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 tooltip="CJEM."/>
              </a:rPr>
              <a:t>CJEM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 tooltip="CJEM."/>
              </a:rPr>
              <a:t>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14;Mar;16(2):106-19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7"/>
              </a:rPr>
              <a:t>Cullen 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8"/>
              </a:rPr>
              <a:t>Greenslade J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9"/>
              </a:rPr>
              <a:t>Than M</a:t>
            </a:r>
            <a:r>
              <a:rPr lang="en-US" sz="1200" u="none" strike="noStrike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new Vancouver Chest Pain Rule using troponin as the only biomarker: an external validation study; </a:t>
            </a:r>
            <a:r>
              <a:rPr lang="en-US" sz="1200" i="1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10" tooltip="The American journal of emergency medicine."/>
              </a:rPr>
              <a:t>Am J Emerg Med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14; Feb;32(2):129-34. doi: </a:t>
            </a:r>
            <a:r>
              <a:rPr lang="en-US" dirty="0">
                <a:hlinkClick r:id="rId11"/>
              </a:rPr>
              <a:t>10.1016/j.ajem.2013.10.02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9131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314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line JA, Johnson CL, Pollack CV, et al. Pretest probability assessment derived from attribute matching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MC Med Inform Decis Mak.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005;5:26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line JA, Zeitouni RA, Hernandez-Nino J, Jones AE. Randomized trial of computerized quantitative pretest probability in low-risk chest pain patients: effect on safety and resource use.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n Emerg Med.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009;53:727–35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an M, Herbert M, Flaws D, et al. What is an acceptable risk of major adverse cardiac event in chest pain patients soon after discharge from the emergency department?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 J Cardiol.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013;166:752–4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5216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gers TT: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isk management in emergency medicine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llas, Emergency Medicine Foundation - American College Emergency Physicians, 1985.</a:t>
            </a:r>
            <a:b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arcz A, Holbrook J, Burke MC, et al: Massachusetts emergency medicine closed malpractice claims: 1988-1990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 Emerg Med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993:22;553-559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ightingale SD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isk preference and admitting rates of emergency room physicians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Med Care. 1988;26:84–7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rson SD, Goldman L, Orav EJ, et al.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iage decisions for emergency department patients with chest pain: do physicians’ risk attitudes make the difference?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 Gen Intern Med. 1995;10:557–64.</a:t>
            </a:r>
          </a:p>
          <a:p>
            <a:endParaRPr lang="en-US" sz="120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ooker JA, Hasting JW, Major-</a:t>
            </a:r>
            <a:r>
              <a:rPr lang="en-US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nfried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, et al., The association between medicolegal and professional concerns and chest pain admission rates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ademic Emergency Medicine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015, 22:883-6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ibler WB. Chest pain evaluation in the ED: beyond triage [Editorial]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m J Emerg M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994;12(1):121–122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9670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Foy AJ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/>
              </a:rPr>
              <a:t>Liu G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5"/>
              </a:rPr>
              <a:t>Davidson WR J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/>
              </a:rPr>
              <a:t>Sciamanna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6"/>
              </a:rPr>
              <a:t> 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7"/>
              </a:rPr>
              <a:t>Leslie D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Comparative effectiveness of diagnostic testing strategies in emergency department patients with chest pain: an analysis of downstream testing, interventions, and outcomes;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8" tooltip="JAMA internal medicine."/>
              </a:rPr>
              <a:t>JAMA Intern Med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15; Mar 175(3):428-36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80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64116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Asher 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/>
              </a:rPr>
              <a:t>Reuveni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/>
              </a:rPr>
              <a:t> 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5"/>
              </a:rPr>
              <a:t>Shlomo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5"/>
              </a:rPr>
              <a:t> N</a:t>
            </a:r>
            <a:r>
              <a:rPr lang="en-US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et al.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inical outcomes and cost effectiveness of accelerated diagnostic protocol in a chest pain center compared with routine care of patients with chest pain; PLoS One; 2015. Jan 26;10(1):e0117287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98547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37608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x AJ, Backus BE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elde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JC.  Chest pain in the emergency room: value of the HEART score. 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Neth Heart J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008;16(6):191-196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x  AJ, Cullen L, Backus BE,  et al.  The HEART score for the assessment of patients with chest pain in the emergency department: a multinational validation study. 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Crit Pathw Cardio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013;12(3):121-126.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hler SA, Riley RF, Hiestand BC, et al. The HEART Pathway Randomized Trial: Identifying Emergency Department Patients With Acute Chest Pain for Early Discharge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irculation Cardiovascular quality and outcome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015;8(2):195-203. doi:10.1161/CIRCOUTCOMES.114.001384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1219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872417-8614-4B09-B5BB-5AA3264E201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519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620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3086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868237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97523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71167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>
  <p:cSld name="Title Slide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2362200" y="4038600"/>
            <a:ext cx="6477000" cy="1828800"/>
          </a:xfrm>
        </p:spPr>
        <p:txBody>
          <a:bodyPr anchor="b"/>
          <a:lstStyle>
            <a:lvl1pPr>
              <a:defRPr cap="all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2362200" y="6050037"/>
            <a:ext cx="6705600" cy="685800"/>
          </a:xfrm>
        </p:spPr>
        <p:txBody>
          <a:bodyPr anchor="ctr">
            <a:normAutofit/>
          </a:bodyPr>
          <a:lstStyle>
            <a:lvl1pPr marL="0" indent="0" algn="l">
              <a:buNone/>
              <a:defRPr sz="2600">
                <a:solidFill>
                  <a:srgbClr val="FFFFFF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/>
              <a:t>Click to edit Master subtitle style</a:t>
            </a:r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>
          <a:xfrm>
            <a:off x="76200" y="6068699"/>
            <a:ext cx="2057400" cy="685800"/>
          </a:xfrm>
        </p:spPr>
        <p:txBody>
          <a:bodyPr>
            <a:noAutofit/>
          </a:bodyPr>
          <a:lstStyle>
            <a:lvl1pPr algn="ctr">
              <a:defRPr sz="2000">
                <a:solidFill>
                  <a:srgbClr val="FFFFFF"/>
                </a:solidFill>
              </a:defRPr>
            </a:lvl1pPr>
          </a:lstStyle>
          <a:p>
            <a:fld id="{7E76624D-2347-4026-B46A-F1E5A7FF2BC2}" type="datetimeFigureOut">
              <a:rPr lang="en-US" smtClean="0"/>
              <a:t>4/19/21</a:t>
            </a:fld>
            <a:endParaRPr lang="en-US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>
          <a:xfrm>
            <a:off x="2085393" y="236538"/>
            <a:ext cx="5867400" cy="365125"/>
          </a:xfrm>
        </p:spPr>
        <p:txBody>
          <a:bodyPr/>
          <a:lstStyle>
            <a:lvl1pPr algn="r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8001000" y="228600"/>
            <a:ext cx="838200" cy="3810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20022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2648" y="228600"/>
            <a:ext cx="8153400" cy="990600"/>
          </a:xfrm>
        </p:spPr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624D-2347-4026-B46A-F1E5A7FF2BC2}" type="datetimeFigureOut">
              <a:rPr lang="en-US" smtClean="0"/>
              <a:t>4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"/>
          </p:nvPr>
        </p:nvSpPr>
        <p:spPr>
          <a:xfrm>
            <a:off x="612648" y="1600200"/>
            <a:ext cx="8153400" cy="44958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</p:spTree>
    <p:extLst>
      <p:ext uri="{BB962C8B-B14F-4D97-AF65-F5344CB8AC3E}">
        <p14:creationId xmlns:p14="http://schemas.microsoft.com/office/powerpoint/2010/main" val="42319231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>
  <p:cSld name="Section Header"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0" y="2743200"/>
            <a:ext cx="7123113" cy="1673225"/>
          </a:xfrm>
        </p:spPr>
        <p:txBody>
          <a:bodyPr anchor="t"/>
          <a:lstStyle>
            <a:lvl1pPr marL="0" indent="0">
              <a:buNone/>
              <a:defRPr sz="280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600" y="1600200"/>
            <a:ext cx="7620000" cy="990600"/>
          </a:xfrm>
        </p:spPr>
        <p:txBody>
          <a:bodyPr/>
          <a:lstStyle>
            <a:lvl1pPr algn="l">
              <a:buNone/>
              <a:defRPr sz="4400" b="0" cap="none">
                <a:solidFill>
                  <a:srgbClr val="FFFFFF"/>
                </a:solidFill>
              </a:defRPr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12" name="Date Placeholder 1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624D-2347-4026-B46A-F1E5A7FF2BC2}" type="datetimeFigureOut">
              <a:rPr lang="en-US" smtClean="0"/>
              <a:t>4/19/21</a:t>
            </a:fld>
            <a:endParaRPr lang="en-US"/>
          </a:p>
        </p:txBody>
      </p:sp>
      <p:sp>
        <p:nvSpPr>
          <p:cNvPr id="13" name="Slide Number Placeholder 12"/>
          <p:cNvSpPr>
            <a:spLocks noGrp="1"/>
          </p:cNvSpPr>
          <p:nvPr>
            <p:ph type="sldNum" sz="quarter" idx="11"/>
          </p:nvPr>
        </p:nvSpPr>
        <p:spPr>
          <a:xfrm>
            <a:off x="0" y="1752600"/>
            <a:ext cx="1295400" cy="701676"/>
          </a:xfrm>
        </p:spPr>
        <p:txBody>
          <a:bodyPr>
            <a:noAutofit/>
          </a:bodyPr>
          <a:lstStyle>
            <a:lvl1pPr>
              <a:defRPr sz="2400">
                <a:solidFill>
                  <a:srgbClr val="FFFFFF"/>
                </a:solidFill>
              </a:defRPr>
            </a:lvl1pPr>
          </a:lstStyle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sp>
        <p:nvSpPr>
          <p:cNvPr id="14" name="Footer Placeholder 13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24373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9626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711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0938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9193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0928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7074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3802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6276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6D84F604-CB1C-4F89-ADA5-87EB8B61D1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179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  <p:sldLayoutId id="2147483852" r:id="rId12"/>
    <p:sldLayoutId id="2147483853" r:id="rId13"/>
    <p:sldLayoutId id="2147483854" r:id="rId14"/>
    <p:sldLayoutId id="2147483855" r:id="rId15"/>
    <p:sldLayoutId id="2147483856" r:id="rId16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5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5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n Approach to Chest Pain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2924AB-5CF2-4B34-9C4A-C144AE0F7855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b="0" i="0" u="none" strike="noStrike" dirty="0">
                <a:solidFill>
                  <a:srgbClr val="FFFFFF"/>
                </a:solidFill>
                <a:latin typeface="Arial"/>
              </a:rPr>
              <a:t>Division </a:t>
            </a:r>
            <a:r>
              <a:rPr lang="en-US" b="0" i="0" u="none" strike="noStrike">
                <a:solidFill>
                  <a:srgbClr val="FFFFFF"/>
                </a:solidFill>
                <a:latin typeface="Arial"/>
              </a:rPr>
              <a:t>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003C15A-A7B7-C94B-A0B8-55F992DC33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3800" y="6259325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55587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T sco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Risk of MACE at 6 weeks:</a:t>
            </a:r>
          </a:p>
          <a:p>
            <a:pPr lvl="1"/>
            <a:r>
              <a:rPr lang="en-US" dirty="0"/>
              <a:t>Score &lt; 3: 1.7%</a:t>
            </a:r>
          </a:p>
          <a:p>
            <a:pPr lvl="2"/>
            <a:r>
              <a:rPr lang="en-US" dirty="0"/>
              <a:t>Serial troponins, EKGS and defer provocative testing</a:t>
            </a:r>
          </a:p>
          <a:p>
            <a:pPr lvl="1"/>
            <a:r>
              <a:rPr lang="en-US" dirty="0"/>
              <a:t>Score 4-6:  12%</a:t>
            </a:r>
          </a:p>
          <a:p>
            <a:pPr lvl="2"/>
            <a:r>
              <a:rPr lang="en-US" dirty="0"/>
              <a:t>Serial troponins, EKGS and continue to provocative testing</a:t>
            </a:r>
          </a:p>
          <a:p>
            <a:pPr lvl="1"/>
            <a:r>
              <a:rPr lang="en-US" dirty="0"/>
              <a:t>Score &gt;6:  65%</a:t>
            </a:r>
          </a:p>
          <a:p>
            <a:pPr lvl="2"/>
            <a:r>
              <a:rPr lang="en-US" dirty="0"/>
              <a:t>Provocative testing versus cardiology consultation for possible LHC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12.1% reduction in cardiac testing</a:t>
            </a:r>
          </a:p>
          <a:p>
            <a:endParaRPr lang="en-US" dirty="0"/>
          </a:p>
          <a:p>
            <a:r>
              <a:rPr lang="en-US" dirty="0"/>
              <a:t>21.3% increase in early discharge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12 hour reduction in average length of stay</a:t>
            </a:r>
          </a:p>
        </p:txBody>
      </p:sp>
    </p:spTree>
    <p:extLst>
      <p:ext uri="{BB962C8B-B14F-4D97-AF65-F5344CB8AC3E}">
        <p14:creationId xmlns:p14="http://schemas.microsoft.com/office/powerpoint/2010/main" val="24944306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IMI Scor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FF34630-25DE-4B59-942B-1E190D95DB8E}"/>
              </a:ext>
            </a:extLst>
          </p:cNvPr>
          <p:cNvSpPr txBox="1"/>
          <p:nvPr/>
        </p:nvSpPr>
        <p:spPr>
          <a:xfrm>
            <a:off x="614923" y="954329"/>
            <a:ext cx="5648116" cy="480131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. Age 65-74= 2 points, &gt;75 = 3 points</a:t>
            </a: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2. Systolic Blood Pressure &lt;100 = 3 points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3. Heart Rate &gt;100 = 2 points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4. Killip Class II-IV = 2 points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5. Anterior ST Elevation or Left Bundle Branch Block = 1 point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6. Diabetes, h/o hypertension (HTN) or h/ angina = 1 point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7. Weight &lt; 67 kg = 1 point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8. Time to Treatment &gt;4 hours = 1 point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39860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IMI Sco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Risk of MACE at 30 days</a:t>
            </a:r>
          </a:p>
          <a:p>
            <a:pPr lvl="1"/>
            <a:r>
              <a:rPr lang="en-US" dirty="0"/>
              <a:t>Score 0-1: 2.1%</a:t>
            </a:r>
          </a:p>
          <a:p>
            <a:pPr lvl="2"/>
            <a:r>
              <a:rPr lang="en-US" dirty="0"/>
              <a:t>Serial troponins, EKGS and defer provocative testing</a:t>
            </a:r>
          </a:p>
          <a:p>
            <a:pPr lvl="1"/>
            <a:r>
              <a:rPr lang="en-US" dirty="0"/>
              <a:t>Score 2-7:  45-100%</a:t>
            </a:r>
          </a:p>
          <a:p>
            <a:pPr lvl="2"/>
            <a:r>
              <a:rPr lang="en-US" dirty="0"/>
              <a:t>Serial troponins, EKGS and continue to provocative testing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718051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EDACS-ADP (accelerated diagnostic pathway)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978188"/>
              </p:ext>
            </p:extLst>
          </p:nvPr>
        </p:nvGraphicFramePr>
        <p:xfrm>
          <a:off x="1143000" y="1828801"/>
          <a:ext cx="6858000" cy="426720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1361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18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1269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linical Characteristics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co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g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18-4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46-5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 dirty="0">
                          <a:effectLst/>
                        </a:rPr>
                        <a:t>51-5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6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 dirty="0">
                          <a:effectLst/>
                        </a:rPr>
                        <a:t>56-60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8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61-6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1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66-7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1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 dirty="0">
                          <a:effectLst/>
                        </a:rPr>
                        <a:t>71-7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1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76-8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16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81-8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18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86+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2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le sex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6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3864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ge 18-50 and either: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 dirty="0">
                          <a:effectLst/>
                        </a:rPr>
                        <a:t>Known CAD or ≥ 3 risk factors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ymptoms and signs (score each if present):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Diaphoresis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3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Radiates to arm or shoulde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+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Pain ↑ occcured or worsened with inspir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2698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100">
                          <a:effectLst/>
                        </a:rPr>
                        <a:t>Pain ↑is reproduced by palp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6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820808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DACS-AD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Low risk if:</a:t>
            </a:r>
          </a:p>
          <a:p>
            <a:pPr lvl="1"/>
            <a:r>
              <a:rPr lang="en-US" dirty="0"/>
              <a:t>EDACS &lt; 16 </a:t>
            </a:r>
          </a:p>
          <a:p>
            <a:pPr lvl="1"/>
            <a:r>
              <a:rPr lang="en-US" b="1" dirty="0"/>
              <a:t>AND</a:t>
            </a:r>
            <a:r>
              <a:rPr lang="en-US" dirty="0"/>
              <a:t> no new ischemia on EKG </a:t>
            </a:r>
          </a:p>
          <a:p>
            <a:pPr lvl="1"/>
            <a:r>
              <a:rPr lang="en-US" b="1" dirty="0"/>
              <a:t>AND</a:t>
            </a:r>
            <a:r>
              <a:rPr lang="en-US" dirty="0"/>
              <a:t> 0h and 2h troponin both negative</a:t>
            </a:r>
          </a:p>
          <a:p>
            <a:pPr marL="365760" lvl="1" indent="0">
              <a:buNone/>
            </a:pPr>
            <a:endParaRPr lang="en-US" dirty="0"/>
          </a:p>
          <a:p>
            <a:pPr lvl="0"/>
            <a:r>
              <a:rPr lang="en-US" dirty="0"/>
              <a:t>Safe to discharge to early outpatient follow up</a:t>
            </a:r>
          </a:p>
          <a:p>
            <a:pPr marL="0" lvl="0" indent="0">
              <a:buNone/>
            </a:pPr>
            <a:endParaRPr lang="en-US" dirty="0"/>
          </a:p>
          <a:p>
            <a:pPr lvl="0"/>
            <a:r>
              <a:rPr lang="en-US" dirty="0"/>
              <a:t>99-100 sensitive for identifying low risk patient for MACE in 30 day follow up perio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33209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Vancouver Chest Pain Ru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Step 1:  If all “no,” move to step 2</a:t>
            </a:r>
          </a:p>
          <a:p>
            <a:pPr lvl="1"/>
            <a:r>
              <a:rPr lang="en-US" dirty="0"/>
              <a:t>Abnormal initial EKG?</a:t>
            </a:r>
          </a:p>
          <a:p>
            <a:pPr lvl="1"/>
            <a:r>
              <a:rPr lang="en-US" dirty="0"/>
              <a:t>Positive troponin at 2 hours?</a:t>
            </a:r>
          </a:p>
          <a:p>
            <a:pPr lvl="1"/>
            <a:r>
              <a:rPr lang="en-US" dirty="0"/>
              <a:t>Prior ACS or nitrate use?</a:t>
            </a:r>
          </a:p>
          <a:p>
            <a:r>
              <a:rPr lang="en-US" dirty="0"/>
              <a:t>Step 2:  If “yes,” proceed to early discharge.  If “no,” proceed to step 3</a:t>
            </a:r>
          </a:p>
          <a:p>
            <a:pPr lvl="1"/>
            <a:r>
              <a:rPr lang="en-US" dirty="0"/>
              <a:t>Does palpation reproduce pain?</a:t>
            </a:r>
          </a:p>
          <a:p>
            <a:r>
              <a:rPr lang="en-US" dirty="0"/>
              <a:t>Step 3:  If “no” to all, proceed to early discharge</a:t>
            </a:r>
          </a:p>
          <a:p>
            <a:pPr lvl="1"/>
            <a:r>
              <a:rPr lang="en-US" dirty="0"/>
              <a:t>Age ≥ 50?</a:t>
            </a:r>
          </a:p>
          <a:p>
            <a:pPr lvl="1"/>
            <a:r>
              <a:rPr lang="en-US" dirty="0"/>
              <a:t>Does pain radiate to neck, jaw, or left arm?</a:t>
            </a:r>
          </a:p>
          <a:p>
            <a:pPr marL="365760" lvl="1" indent="0">
              <a:buNone/>
            </a:pPr>
            <a:endParaRPr lang="en-US" dirty="0"/>
          </a:p>
          <a:p>
            <a:r>
              <a:rPr lang="en-US" dirty="0"/>
              <a:t>99-100% sensitive  and 18.6-23.4% specific for identifying low risk patients for early discharge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19% lost to follow up at 30 day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661319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431" y="2360995"/>
            <a:ext cx="8153400" cy="990600"/>
          </a:xfrm>
        </p:spPr>
        <p:txBody>
          <a:bodyPr>
            <a:normAutofit/>
          </a:bodyPr>
          <a:lstStyle/>
          <a:p>
            <a:r>
              <a:rPr lang="en-US" dirty="0"/>
              <a:t>Provocative Testing</a:t>
            </a:r>
          </a:p>
        </p:txBody>
      </p:sp>
    </p:spTree>
    <p:extLst>
      <p:ext uri="{BB962C8B-B14F-4D97-AF65-F5344CB8AC3E}">
        <p14:creationId xmlns:p14="http://schemas.microsoft.com/office/powerpoint/2010/main" val="20832764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Absolute Contraindication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pPr lvl="0"/>
            <a:r>
              <a:rPr lang="en-US" dirty="0"/>
              <a:t>Acute myocardial infarction (MI; within 2 days) </a:t>
            </a:r>
          </a:p>
          <a:p>
            <a:pPr lvl="0"/>
            <a:r>
              <a:rPr lang="en-US" dirty="0"/>
              <a:t>Unstable angina not previously stabilized by medical therapy – Appropriate timing of tests depends on the level of risk of unstable angina as defined by the Agency for Health Care Policy and Research Unstable Angina Guidelines </a:t>
            </a:r>
          </a:p>
          <a:p>
            <a:pPr lvl="0"/>
            <a:r>
              <a:rPr lang="en-US" dirty="0"/>
              <a:t>Uncontrolled cardiac arrhythmias causing symptoms or hemodynamic compromise </a:t>
            </a:r>
          </a:p>
          <a:p>
            <a:pPr lvl="0"/>
            <a:r>
              <a:rPr lang="en-US" dirty="0"/>
              <a:t>Symptomatic severe aortic stenosis </a:t>
            </a:r>
          </a:p>
          <a:p>
            <a:pPr lvl="0"/>
            <a:r>
              <a:rPr lang="en-US" dirty="0"/>
              <a:t>Uncontrolled symptomatic heart failure </a:t>
            </a:r>
          </a:p>
          <a:p>
            <a:pPr lvl="0"/>
            <a:r>
              <a:rPr lang="en-US" dirty="0"/>
              <a:t>Acute pulmonary embolus or pulmonary infarction </a:t>
            </a:r>
          </a:p>
          <a:p>
            <a:pPr lvl="0"/>
            <a:r>
              <a:rPr lang="en-US" dirty="0"/>
              <a:t>Acute myocarditis or pericarditis </a:t>
            </a:r>
          </a:p>
          <a:p>
            <a:pPr lvl="0"/>
            <a:r>
              <a:rPr lang="en-US" dirty="0"/>
              <a:t>Acute aortic dissection </a:t>
            </a:r>
          </a:p>
        </p:txBody>
      </p:sp>
    </p:spTree>
    <p:extLst>
      <p:ext uri="{BB962C8B-B14F-4D97-AF65-F5344CB8AC3E}">
        <p14:creationId xmlns:p14="http://schemas.microsoft.com/office/powerpoint/2010/main" val="348888522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elative Contraind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pPr lvl="0"/>
            <a:r>
              <a:rPr lang="en-US" dirty="0"/>
              <a:t>Left main coronary stenosis </a:t>
            </a:r>
          </a:p>
          <a:p>
            <a:pPr lvl="0"/>
            <a:r>
              <a:rPr lang="en-US" dirty="0"/>
              <a:t>Moderate stenotic valvular heart disease </a:t>
            </a:r>
          </a:p>
          <a:p>
            <a:pPr lvl="0"/>
            <a:r>
              <a:rPr lang="en-US" dirty="0"/>
              <a:t>Electrolyte abnormalities </a:t>
            </a:r>
          </a:p>
          <a:p>
            <a:pPr lvl="0"/>
            <a:r>
              <a:rPr lang="en-US" dirty="0"/>
              <a:t>Severe arterial hypertension – In the absence of definite evidence, the committee suggests an SBP higher than 200 mm Hg, a DBP higher than 110 mm Hg, or both </a:t>
            </a:r>
          </a:p>
          <a:p>
            <a:pPr lvl="0"/>
            <a:r>
              <a:rPr lang="en-US" dirty="0"/>
              <a:t>Tachyarrhythmias or bradyarrhythmias </a:t>
            </a:r>
          </a:p>
          <a:p>
            <a:pPr lvl="0"/>
            <a:r>
              <a:rPr lang="en-US" dirty="0"/>
              <a:t>Hypertrophic cardiomyopathy and any other forms of outflow tract obstruction </a:t>
            </a:r>
          </a:p>
          <a:p>
            <a:pPr lvl="0"/>
            <a:r>
              <a:rPr lang="en-US" dirty="0"/>
              <a:t>Mental or physical impairment leading to an inability to exercise adequately </a:t>
            </a:r>
          </a:p>
          <a:p>
            <a:pPr lvl="0"/>
            <a:r>
              <a:rPr lang="en-US" dirty="0"/>
              <a:t>High-degree atrioventricular (AV) block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10913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oosing wisely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8529362"/>
              </p:ext>
            </p:extLst>
          </p:nvPr>
        </p:nvGraphicFramePr>
        <p:xfrm>
          <a:off x="838200" y="1676399"/>
          <a:ext cx="7620000" cy="417157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54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40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40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Modality</a:t>
                      </a:r>
                      <a:endParaRPr lang="en-US" sz="16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Sensitivity %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Specificity %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Exercise 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70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75-80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uclear exercise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87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64-70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uclear vasodilator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89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77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uclear dobutamine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84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79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Exercise echocardiography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85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77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obutamine echocardiography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80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82-84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CCTA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98-99</a:t>
                      </a:r>
                      <a:endParaRPr lang="en-US" sz="1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82-89</a:t>
                      </a:r>
                      <a:endParaRPr lang="en-US" sz="16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102102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pidemiology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6 Million ED visits per year for the evaluation of chest pain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Most common chief complaint for adults &gt; 65 years:  Chest pain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Most common chief complaints for adults 15-64 years old:  Chest and abdominal pain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10-12 billion dollars a year spent on the evaluation of chest pain </a:t>
            </a:r>
          </a:p>
        </p:txBody>
      </p:sp>
    </p:spTree>
    <p:extLst>
      <p:ext uri="{BB962C8B-B14F-4D97-AF65-F5344CB8AC3E}">
        <p14:creationId xmlns:p14="http://schemas.microsoft.com/office/powerpoint/2010/main" val="250683098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22292" y="2107999"/>
            <a:ext cx="8153400" cy="990600"/>
          </a:xfrm>
        </p:spPr>
        <p:txBody>
          <a:bodyPr>
            <a:normAutofit/>
          </a:bodyPr>
          <a:lstStyle/>
          <a:p>
            <a:r>
              <a:rPr lang="en-US" dirty="0"/>
              <a:t>Pharmacologic agents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99890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enosine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1"/>
          </p:nvPr>
        </p:nvSpPr>
        <p:spPr>
          <a:xfrm>
            <a:off x="457200" y="1600201"/>
            <a:ext cx="8229600" cy="838200"/>
          </a:xfrm>
        </p:spPr>
        <p:txBody>
          <a:bodyPr>
            <a:normAutofit/>
          </a:bodyPr>
          <a:lstStyle/>
          <a:p>
            <a:pPr lvl="0"/>
            <a:r>
              <a:rPr lang="en-US" dirty="0"/>
              <a:t>Aa2 adenosine receptor agonist &gt; vasodilator &gt; increase coronary blood flow circulation</a:t>
            </a:r>
          </a:p>
          <a:p>
            <a:endParaRPr lang="en-US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4331415"/>
              </p:ext>
            </p:extLst>
          </p:nvPr>
        </p:nvGraphicFramePr>
        <p:xfrm>
          <a:off x="685800" y="2895600"/>
          <a:ext cx="7696200" cy="31140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848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48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6389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Absolute </a:t>
                      </a:r>
                      <a:endParaRPr lang="en-US" sz="1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elative</a:t>
                      </a:r>
                      <a:endParaRPr lang="en-US" sz="1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45902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Bronchospasm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800" b="0" baseline="30000" dirty="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 degree </a:t>
                      </a:r>
                      <a:r>
                        <a:rPr lang="en-US" b="0" baseline="0" dirty="0">
                          <a:solidFill>
                            <a:schemeClr val="tx1"/>
                          </a:solidFill>
                        </a:rPr>
                        <a:t>atrioventricular block</a:t>
                      </a:r>
                      <a:r>
                        <a:rPr lang="en-US" dirty="0"/>
                        <a:t> </a:t>
                      </a:r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(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AVB) and higher, without a ventricular demand pace maker (PM)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SBP &lt; 90 mm Hg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Current use of dipyridamole, methylxanthines ie, caffeine, aminophylline</a:t>
                      </a:r>
                      <a:endParaRPr lang="en-US" sz="18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dirty="0">
                          <a:effectLst/>
                        </a:rPr>
                        <a:t>Remote hx of reactive airway disease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dirty="0">
                          <a:effectLst/>
                        </a:rPr>
                        <a:t>Sick sinus syndrome (SSS) without ventricular demand PM</a:t>
                      </a:r>
                      <a:endParaRPr lang="en-US" sz="1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224592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Dipyridamole (Persant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1"/>
            <a:ext cx="8229600" cy="1219200"/>
          </a:xfrm>
        </p:spPr>
        <p:txBody>
          <a:bodyPr>
            <a:normAutofit/>
          </a:bodyPr>
          <a:lstStyle/>
          <a:p>
            <a:pPr lvl="0"/>
            <a:r>
              <a:rPr lang="en-US" dirty="0"/>
              <a:t>Inhibits activity of adenosine deaminase and PDE &gt; increased cAMP &gt; vasodilation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9935234"/>
              </p:ext>
            </p:extLst>
          </p:nvPr>
        </p:nvGraphicFramePr>
        <p:xfrm>
          <a:off x="838200" y="2819400"/>
          <a:ext cx="7543800" cy="283975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7719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719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363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Absolute</a:t>
                      </a:r>
                      <a:endParaRPr lang="en-US" sz="1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elative</a:t>
                      </a:r>
                      <a:endParaRPr lang="en-US" sz="1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83071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Active bronchospasm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800" b="0" baseline="30000" dirty="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 degree AVB and higher, without a ventricular demand PM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SBP &lt; 90 mm Hg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Current use of dipyridamole, methylxanthines ie, caffeine, aminophylline</a:t>
                      </a:r>
                      <a:endParaRPr lang="en-US" sz="18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dirty="0">
                          <a:effectLst/>
                        </a:rPr>
                        <a:t>Remote </a:t>
                      </a:r>
                      <a:r>
                        <a:rPr lang="en-US" sz="1800" dirty="0" err="1">
                          <a:effectLst/>
                        </a:rPr>
                        <a:t>hx</a:t>
                      </a:r>
                      <a:r>
                        <a:rPr lang="en-US" sz="1800" dirty="0">
                          <a:effectLst/>
                        </a:rPr>
                        <a:t> of reactive airway disease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dirty="0">
                          <a:effectLst/>
                        </a:rPr>
                        <a:t>SSS without ventricular demand PM</a:t>
                      </a:r>
                      <a:endParaRPr lang="en-US" sz="1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4862542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obutamin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1"/>
            <a:ext cx="8229600" cy="1219200"/>
          </a:xfrm>
        </p:spPr>
        <p:txBody>
          <a:bodyPr/>
          <a:lstStyle/>
          <a:p>
            <a:pPr lvl="0"/>
            <a:r>
              <a:rPr lang="en-US" dirty="0"/>
              <a:t>B1 adrenergic agonist primarily &gt; increase heart rate and cardiac contractility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8759186"/>
              </p:ext>
            </p:extLst>
          </p:nvPr>
        </p:nvGraphicFramePr>
        <p:xfrm>
          <a:off x="762000" y="2894899"/>
          <a:ext cx="7696200" cy="279857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696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3502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Absolute Contraindications</a:t>
                      </a:r>
                      <a:endParaRPr lang="en-US" sz="1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75474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Recent MI (1 week)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UA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Significant aortic stenosis or obstructive cardiomyopathy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Atrial tachyarrhythmia with rapid ventricular response (RVR)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History of v-tach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Uncontrolled hypertension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Thoracic aortic aneurysm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LBBB</a:t>
                      </a:r>
                      <a:endParaRPr lang="en-US" sz="18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456943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egadenoson (Lexiscan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1"/>
            <a:ext cx="8229600" cy="1219200"/>
          </a:xfrm>
        </p:spPr>
        <p:txBody>
          <a:bodyPr>
            <a:normAutofit/>
          </a:bodyPr>
          <a:lstStyle/>
          <a:p>
            <a:pPr lvl="0"/>
            <a:r>
              <a:rPr lang="en-US" dirty="0"/>
              <a:t>Aa2 adenosine receptor agonist &gt; vasodilator &gt; increase coronary blood flow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1592278"/>
              </p:ext>
            </p:extLst>
          </p:nvPr>
        </p:nvGraphicFramePr>
        <p:xfrm>
          <a:off x="685800" y="3124200"/>
          <a:ext cx="7620000" cy="12954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62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42301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dirty="0">
                          <a:effectLst/>
                        </a:rPr>
                        <a:t>Absolute Contraindications</a:t>
                      </a:r>
                      <a:endParaRPr lang="en-US" sz="1800" b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2382"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800" b="0" baseline="30000" dirty="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 degree AVB without PM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/>
                        <a:buChar char=""/>
                      </a:pPr>
                      <a:r>
                        <a:rPr lang="en-US" sz="1800" b="0" dirty="0">
                          <a:solidFill>
                            <a:schemeClr val="tx1"/>
                          </a:solidFill>
                          <a:effectLst/>
                        </a:rPr>
                        <a:t>Sinus node dysfunction without PM</a:t>
                      </a:r>
                      <a:endParaRPr lang="en-US" sz="18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185419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B7935-FA3C-4A3A-AD84-8781845F66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Referenc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9654F1-C0F8-4043-B738-A2FDBD28435D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491052" y="1490764"/>
            <a:ext cx="8153400" cy="4909225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1. </a:t>
            </a:r>
            <a:r>
              <a:rPr lang="en-US" dirty="0">
                <a:ea typeface="+mn-lt"/>
                <a:cs typeface="+mn-lt"/>
              </a:rPr>
              <a:t>Aragam KG, Tamhane UU, Kline-Rogers E, et al. Does simplicity compromise accuracy in ACS risk prediction? A retrospective analysis of the TIMI and GRACE risk scores. </a:t>
            </a:r>
            <a:r>
              <a:rPr lang="en-US" i="1" dirty="0">
                <a:ea typeface="+mn-lt"/>
                <a:cs typeface="+mn-lt"/>
              </a:rPr>
              <a:t>PLoS One</a:t>
            </a:r>
            <a:r>
              <a:rPr lang="en-US" dirty="0">
                <a:ea typeface="+mn-lt"/>
                <a:cs typeface="+mn-lt"/>
              </a:rPr>
              <a:t>. 2009;4(11):e7947. Published 2009 Nov 23. doi:10.1371/journal.pone.0007947</a:t>
            </a:r>
          </a:p>
          <a:p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2. Fleischmann KE, Hunink MG, Kuntz KM, Douglas PS; Exercise echocardiography or exercise SPECT imaging? A meta-analysis of diagnostic test performance. JAMA. 1998 Sep 9                                                            :280(10):913-20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3. Kim C, Kwok YS, Heagerty P, Redberg R. Pharmacologic stress testing for coronary disease diagnosis: A meta-analysis. </a:t>
            </a:r>
            <a:r>
              <a:rPr lang="en-US" i="1" dirty="0">
                <a:ea typeface="+mn-lt"/>
                <a:cs typeface="+mn-lt"/>
              </a:rPr>
              <a:t>Am Heart J</a:t>
            </a:r>
            <a:r>
              <a:rPr lang="en-US" dirty="0">
                <a:ea typeface="+mn-lt"/>
                <a:cs typeface="+mn-lt"/>
              </a:rPr>
              <a:t>. 2001;142(6):934-944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4. Gianrossi R, Detrano R, Mulvihill D, et al. Exercise-induced ST depression in the diagnosis of coronary artery disease. A meta-analysis. </a:t>
            </a:r>
            <a:r>
              <a:rPr lang="en-US" i="1" dirty="0">
                <a:ea typeface="+mn-lt"/>
                <a:cs typeface="+mn-lt"/>
              </a:rPr>
              <a:t>Circulation</a:t>
            </a:r>
            <a:r>
              <a:rPr lang="en-US" dirty="0">
                <a:ea typeface="+mn-lt"/>
                <a:cs typeface="+mn-lt"/>
              </a:rPr>
              <a:t>. 1989;80(1):87-98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5. Mowatt G, Cook JA, Hillis GS, et al. 64-Slice computed tomography angiography in the diagnosis and assessment of coronary artery disease: systematic review and meta-analysis. </a:t>
            </a:r>
            <a:r>
              <a:rPr lang="en-US" i="1" dirty="0">
                <a:ea typeface="+mn-lt"/>
                <a:cs typeface="+mn-lt"/>
              </a:rPr>
              <a:t>Heart</a:t>
            </a:r>
            <a:r>
              <a:rPr lang="en-US" dirty="0">
                <a:ea typeface="+mn-lt"/>
                <a:cs typeface="+mn-lt"/>
              </a:rPr>
              <a:t>. 2008;94(11):1386-1393.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dirty="0">
                <a:ea typeface="+mn-lt"/>
                <a:cs typeface="+mn-lt"/>
              </a:rPr>
              <a:t>6. Arbab-Zadeh A. Stress testing and non-invasive coronary angiography in patients with suspected coronary artery disease: time for a new paradigm. </a:t>
            </a:r>
            <a:r>
              <a:rPr lang="en-US" i="1" dirty="0">
                <a:ea typeface="+mn-lt"/>
                <a:cs typeface="+mn-lt"/>
              </a:rPr>
              <a:t>Heart Int</a:t>
            </a:r>
            <a:r>
              <a:rPr lang="en-US" dirty="0">
                <a:ea typeface="+mn-lt"/>
                <a:cs typeface="+mn-lt"/>
              </a:rPr>
              <a:t>. 2012; 7(1):e2. doi: 10.4081/hi.2012.e2. Epub 2012 Feb 8. PMID: 22690295; PMCID: PMC3366298.</a:t>
            </a:r>
          </a:p>
        </p:txBody>
      </p:sp>
    </p:spTree>
    <p:extLst>
      <p:ext uri="{BB962C8B-B14F-4D97-AF65-F5344CB8AC3E}">
        <p14:creationId xmlns:p14="http://schemas.microsoft.com/office/powerpoint/2010/main" val="2260740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Chest Pain:  Not a zero risk compla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For patients:  a missed diagnosis can lead to MACE and associated morbidity or mortality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For providers:  a missed diagnosis can result in expensive litigation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66021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Chest Pain:  Not a zero risk compla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About 10% of patients with acute chest pain will be diagnosed with acute coronary syndrome (ACS)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Multiple studies have shown, despite all reasonable efforts, the miss rate for ACS in the evaluation of chest pain is approximately 1-2%  </a:t>
            </a:r>
          </a:p>
          <a:p>
            <a:endParaRPr lang="en-US" dirty="0"/>
          </a:p>
          <a:p>
            <a:r>
              <a:rPr lang="en-US" dirty="0"/>
              <a:t>Chest pain and a missed acute myocardial infarction (AMI) has the highest per claim pay in medicolegal proceeding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20% of medicolegal claims pertain to chest pain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Fear of medicolegal proceedings can change physician behavior leading to a tendency towards overly conservative behaviors such as increased admission rates, increased testing and increased healthcare expenditures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95489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easonable care is good ca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 fontScale="92500"/>
          </a:bodyPr>
          <a:lstStyle/>
          <a:p>
            <a:r>
              <a:rPr lang="en-US" dirty="0"/>
              <a:t>Stress testing everyone with chest pain is not the answer</a:t>
            </a:r>
          </a:p>
          <a:p>
            <a:pPr marL="0" indent="0">
              <a:buNone/>
            </a:pPr>
            <a:r>
              <a:rPr lang="en-US" dirty="0"/>
              <a:t> </a:t>
            </a:r>
          </a:p>
          <a:p>
            <a:r>
              <a:rPr lang="en-US" dirty="0"/>
              <a:t>There are consequences to over-diagnosis &gt; added interventions without reductions in the rate of major adverse cardiac events (MACE) post discharge, complication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100,000 patients who get myocardial perfusion scintigraphy (MPS) &gt; 3 700 unnecessary left heart catherizations (LHC) (1/27)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100,000 patients who get cardiac computed tomography angiography (CCTA) &gt; 800 unnecessary LHC (1/71)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Patients with low risk chest pain did not have different short or long term outcomes for an early non-invasive testing strategy (EE, MPS, CCTA) versus a no-test strategy (ie, serial trops and outpatient stress testing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06330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07" y="78911"/>
            <a:ext cx="8229600" cy="1143000"/>
          </a:xfrm>
        </p:spPr>
        <p:txBody>
          <a:bodyPr>
            <a:normAutofit fontScale="90000"/>
          </a:bodyPr>
          <a:lstStyle/>
          <a:p>
            <a:br>
              <a:rPr lang="en-US" sz="4000" b="1" dirty="0"/>
            </a:br>
            <a:r>
              <a:rPr lang="en-US" sz="4000" dirty="0"/>
              <a:t>Chest Pain:  An evidence based approach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558435" y="2061014"/>
            <a:ext cx="8153400" cy="4495800"/>
          </a:xfrm>
        </p:spPr>
        <p:txBody>
          <a:bodyPr>
            <a:normAutofit/>
          </a:bodyPr>
          <a:lstStyle/>
          <a:p>
            <a:r>
              <a:rPr lang="en-US" dirty="0"/>
              <a:t>Risk stratification tool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dentification of low risk patient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dentification of patients for further provocative testing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The need and rise of the observation unit for the evaluation of chest pain</a:t>
            </a:r>
          </a:p>
        </p:txBody>
      </p:sp>
    </p:spTree>
    <p:extLst>
      <p:ext uri="{BB962C8B-B14F-4D97-AF65-F5344CB8AC3E}">
        <p14:creationId xmlns:p14="http://schemas.microsoft.com/office/powerpoint/2010/main" val="36007505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100" dirty="0"/>
              <a:t>Emergency department observation unit (EDOU) vs 'routine' inpatient care for chest pai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Differentiating those patients who need immediate work up now versus those who can be deferred to a later time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dentifying low risk patients is the cornerstone of an efficient and effective strategy for evaluating acute chest pain patients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Shorter length of stay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Shorter time from symptom onset to definitive diagnosis</a:t>
            </a:r>
            <a:endParaRPr lang="en-US" dirty="0">
              <a:cs typeface="Arial"/>
            </a:endParaRP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Lower readmission rate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45857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Risk stratification tool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HEART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TIMI (thrombolysis in myocardial infarction risk score)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EDACS (emergency department assessment of chest pain score)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Vancouver Chest Pain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22825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HEART scor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B91D501-8E67-45BD-AF62-1442E8518BC1}"/>
              </a:ext>
            </a:extLst>
          </p:cNvPr>
          <p:cNvSpPr txBox="1"/>
          <p:nvPr/>
        </p:nvSpPr>
        <p:spPr>
          <a:xfrm>
            <a:off x="375343" y="624906"/>
            <a:ext cx="8483153" cy="473975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endParaRPr lang="en-US" sz="1600" b="1" u="sng" dirty="0">
              <a:solidFill>
                <a:schemeClr val="bg1"/>
              </a:solidFill>
              <a:cs typeface="Arial"/>
            </a:endParaRPr>
          </a:p>
          <a:p>
            <a:r>
              <a:rPr lang="en-US" b="1" u="sng" dirty="0">
                <a:solidFill>
                  <a:schemeClr val="bg1"/>
                </a:solidFill>
                <a:cs typeface="Arial"/>
              </a:rPr>
              <a:t>H</a:t>
            </a:r>
            <a:r>
              <a:rPr lang="en-US" b="1" dirty="0">
                <a:solidFill>
                  <a:schemeClr val="bg1"/>
                </a:solidFill>
                <a:cs typeface="Arial"/>
              </a:rPr>
              <a:t>istory (anamnesis):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Highly Suspicious: 2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Moderately Suspicious: 1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Slightly Suspicious: 0</a:t>
            </a: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b="1" u="sng" dirty="0">
                <a:solidFill>
                  <a:schemeClr val="bg1"/>
                </a:solidFill>
                <a:cs typeface="Arial"/>
              </a:rPr>
              <a:t>E</a:t>
            </a:r>
            <a:r>
              <a:rPr lang="en-US" b="1" dirty="0">
                <a:solidFill>
                  <a:schemeClr val="bg1"/>
                </a:solidFill>
                <a:cs typeface="Arial"/>
              </a:rPr>
              <a:t>CG: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Significant ST-segment deviation: 2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Nonspecific  repolarization disturbance/LBBB/PM: 1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Normal: 0</a:t>
            </a:r>
          </a:p>
          <a:p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b="1" u="sng" dirty="0">
                <a:solidFill>
                  <a:schemeClr val="bg1"/>
                </a:solidFill>
                <a:cs typeface="Arial"/>
              </a:rPr>
              <a:t>A</a:t>
            </a:r>
            <a:r>
              <a:rPr lang="en-US" b="1" dirty="0">
                <a:solidFill>
                  <a:schemeClr val="bg1"/>
                </a:solidFill>
                <a:cs typeface="Arial"/>
              </a:rPr>
              <a:t>ge: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 </a:t>
            </a:r>
            <a:r>
              <a:rPr lang="en-US" u="sng" dirty="0">
                <a:solidFill>
                  <a:schemeClr val="bg1"/>
                </a:solidFill>
                <a:cs typeface="Arial"/>
              </a:rPr>
              <a:t>&gt;</a:t>
            </a:r>
            <a:r>
              <a:rPr lang="en-US" dirty="0">
                <a:solidFill>
                  <a:schemeClr val="bg1"/>
                </a:solidFill>
                <a:cs typeface="Arial"/>
              </a:rPr>
              <a:t> 65 years old: 2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Between 45-65 years old: 1</a:t>
            </a:r>
          </a:p>
          <a:p>
            <a:r>
              <a:rPr lang="en-US" dirty="0">
                <a:solidFill>
                  <a:schemeClr val="bg1"/>
                </a:solidFill>
                <a:cs typeface="Arial"/>
              </a:rPr>
              <a:t>- </a:t>
            </a:r>
            <a:r>
              <a:rPr lang="en-US" u="sng" dirty="0">
                <a:solidFill>
                  <a:schemeClr val="bg1"/>
                </a:solidFill>
                <a:cs typeface="Arial"/>
              </a:rPr>
              <a:t>&lt;</a:t>
            </a:r>
            <a:r>
              <a:rPr lang="en-US" dirty="0">
                <a:solidFill>
                  <a:schemeClr val="bg1"/>
                </a:solidFill>
                <a:cs typeface="Arial"/>
              </a:rPr>
              <a:t> 45 years old: 0</a:t>
            </a:r>
          </a:p>
          <a:p>
            <a:endParaRPr lang="en-US" sz="1600" dirty="0">
              <a:solidFill>
                <a:schemeClr val="bg1"/>
              </a:solidFill>
              <a:cs typeface="Arial"/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70A2F6D-5D68-4CE5-B660-E1AB7580BD9C}"/>
              </a:ext>
            </a:extLst>
          </p:cNvPr>
          <p:cNvSpPr txBox="1"/>
          <p:nvPr/>
        </p:nvSpPr>
        <p:spPr>
          <a:xfrm>
            <a:off x="6035438" y="574993"/>
            <a:ext cx="2743199" cy="34163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endParaRPr lang="en-US" dirty="0">
              <a:ea typeface="+mn-lt"/>
              <a:cs typeface="+mn-lt"/>
            </a:endParaRPr>
          </a:p>
          <a:p>
            <a:r>
              <a:rPr lang="en-US" b="1" u="sng" dirty="0">
                <a:solidFill>
                  <a:schemeClr val="bg1"/>
                </a:solidFill>
                <a:ea typeface="+mn-lt"/>
                <a:cs typeface="+mn-lt"/>
              </a:rPr>
              <a:t>R</a:t>
            </a:r>
            <a:r>
              <a:rPr lang="en-US" b="1" dirty="0">
                <a:solidFill>
                  <a:schemeClr val="bg1"/>
                </a:solidFill>
                <a:ea typeface="+mn-lt"/>
                <a:cs typeface="+mn-lt"/>
              </a:rPr>
              <a:t>isk Factors: </a:t>
            </a:r>
            <a:endParaRPr lang="en-US" dirty="0">
              <a:solidFill>
                <a:schemeClr val="bg1"/>
              </a:solidFill>
              <a:ea typeface="+mn-lt"/>
              <a:cs typeface="+mn-lt"/>
            </a:endParaRPr>
          </a:p>
          <a:p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- </a:t>
            </a:r>
            <a:r>
              <a:rPr lang="en-US" u="sng" dirty="0">
                <a:solidFill>
                  <a:schemeClr val="bg1"/>
                </a:solidFill>
                <a:ea typeface="+mn-lt"/>
                <a:cs typeface="+mn-lt"/>
              </a:rPr>
              <a:t>&gt;</a:t>
            </a:r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3 risk factors or history of atherosclerotic disease: 2</a:t>
            </a:r>
          </a:p>
          <a:p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- 1 or 2 risk factors: 1</a:t>
            </a:r>
          </a:p>
          <a:p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- no risk factors: 0</a:t>
            </a:r>
          </a:p>
          <a:p>
            <a:endParaRPr lang="en-US" dirty="0">
              <a:ea typeface="+mn-lt"/>
              <a:cs typeface="+mn-lt"/>
            </a:endParaRPr>
          </a:p>
          <a:p>
            <a:r>
              <a:rPr lang="en-US" b="1" u="sng" dirty="0">
                <a:solidFill>
                  <a:schemeClr val="bg1"/>
                </a:solidFill>
                <a:ea typeface="+mn-lt"/>
                <a:cs typeface="+mn-lt"/>
              </a:rPr>
              <a:t>T</a:t>
            </a:r>
            <a:r>
              <a:rPr lang="en-US" b="1" dirty="0">
                <a:solidFill>
                  <a:schemeClr val="bg1"/>
                </a:solidFill>
                <a:ea typeface="+mn-lt"/>
                <a:cs typeface="+mn-lt"/>
              </a:rPr>
              <a:t>roponin: </a:t>
            </a:r>
            <a:endParaRPr lang="en-US" dirty="0">
              <a:solidFill>
                <a:schemeClr val="bg1"/>
              </a:solidFill>
              <a:ea typeface="+mn-lt"/>
              <a:cs typeface="+mn-lt"/>
            </a:endParaRPr>
          </a:p>
          <a:p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- </a:t>
            </a:r>
            <a:r>
              <a:rPr lang="en-US" u="sng" dirty="0">
                <a:solidFill>
                  <a:schemeClr val="bg1"/>
                </a:solidFill>
                <a:ea typeface="+mn-lt"/>
                <a:cs typeface="+mn-lt"/>
              </a:rPr>
              <a:t>&gt;</a:t>
            </a:r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 3x normal limit: 2</a:t>
            </a:r>
          </a:p>
          <a:p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- 1-3x normal limit: 1</a:t>
            </a:r>
          </a:p>
          <a:p>
            <a:r>
              <a:rPr lang="en-US" dirty="0">
                <a:solidFill>
                  <a:schemeClr val="bg1"/>
                </a:solidFill>
                <a:ea typeface="+mn-lt"/>
                <a:cs typeface="+mn-lt"/>
              </a:rPr>
              <a:t>- normal limit or below: 0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5CA121-0523-4ECE-A256-545A8940C596}"/>
              </a:ext>
            </a:extLst>
          </p:cNvPr>
          <p:cNvSpPr txBox="1"/>
          <p:nvPr/>
        </p:nvSpPr>
        <p:spPr>
          <a:xfrm>
            <a:off x="1955702" y="5409657"/>
            <a:ext cx="538857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b="1" dirty="0">
                <a:solidFill>
                  <a:srgbClr val="FFFFFF"/>
                </a:solidFill>
              </a:rPr>
              <a:t>Sum each category to determine total HEART Score</a:t>
            </a:r>
            <a:endParaRPr lang="en-US" b="1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52938700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287</TotalTime>
  <Words>2484</Words>
  <Application>Microsoft Macintosh PowerPoint</Application>
  <PresentationFormat>On-screen Show (4:3)</PresentationFormat>
  <Paragraphs>327</Paragraphs>
  <Slides>25</Slides>
  <Notes>1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0" baseType="lpstr">
      <vt:lpstr>Arial</vt:lpstr>
      <vt:lpstr>Calibri</vt:lpstr>
      <vt:lpstr>Lucida Grande</vt:lpstr>
      <vt:lpstr>Symbol</vt:lpstr>
      <vt:lpstr>NYU Theme</vt:lpstr>
      <vt:lpstr>An Approach to Chest Pain</vt:lpstr>
      <vt:lpstr>Epidemiology</vt:lpstr>
      <vt:lpstr>Chest Pain:  Not a zero risk complaint</vt:lpstr>
      <vt:lpstr>Chest Pain:  Not a zero risk complaint</vt:lpstr>
      <vt:lpstr>Reasonable care is good care</vt:lpstr>
      <vt:lpstr> Chest Pain:  An evidence based approach </vt:lpstr>
      <vt:lpstr>Emergency department observation unit (EDOU) vs 'routine' inpatient care for chest pain</vt:lpstr>
      <vt:lpstr>Risk stratification tools</vt:lpstr>
      <vt:lpstr>HEART score</vt:lpstr>
      <vt:lpstr>HEART score</vt:lpstr>
      <vt:lpstr>TIMI Score</vt:lpstr>
      <vt:lpstr>TIMI Score</vt:lpstr>
      <vt:lpstr>EDACS-ADP (accelerated diagnostic pathway)</vt:lpstr>
      <vt:lpstr>EDACS-ADP</vt:lpstr>
      <vt:lpstr>Vancouver Chest Pain Rule</vt:lpstr>
      <vt:lpstr>Provocative Testing</vt:lpstr>
      <vt:lpstr>Absolute Contraindications</vt:lpstr>
      <vt:lpstr>Relative Contraindications</vt:lpstr>
      <vt:lpstr>Choosing wisely</vt:lpstr>
      <vt:lpstr>Pharmacologic agents </vt:lpstr>
      <vt:lpstr>Adenosine</vt:lpstr>
      <vt:lpstr>Dipyridamole (Persantine)</vt:lpstr>
      <vt:lpstr>Dobutamine</vt:lpstr>
      <vt:lpstr>Regadenoson (Lexiscan)</vt:lpstr>
      <vt:lpstr>References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est Pain ACS</dc:title>
  <dc:creator>Admin</dc:creator>
  <cp:lastModifiedBy>Toohey, Shannon</cp:lastModifiedBy>
  <cp:revision>183</cp:revision>
  <dcterms:created xsi:type="dcterms:W3CDTF">2017-09-09T18:23:48Z</dcterms:created>
  <dcterms:modified xsi:type="dcterms:W3CDTF">2021-04-19T16:19:15Z</dcterms:modified>
</cp:coreProperties>
</file>